
<file path=[Content_Types].xml><?xml version="1.0" encoding="utf-8"?>
<Types xmlns="http://schemas.openxmlformats.org/package/2006/content-types"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6" Type="http://schemas.openxmlformats.org/officeDocument/2006/relationships/slideLayout" Target="../slideLayouts/slideLayout1.xml"/><Relationship Id="rId25" Type="http://schemas.openxmlformats.org/officeDocument/2006/relationships/tags" Target="../tags/tag63.xml"/><Relationship Id="rId24" Type="http://schemas.openxmlformats.org/officeDocument/2006/relationships/image" Target="../media/image24.png"/><Relationship Id="rId23" Type="http://schemas.openxmlformats.org/officeDocument/2006/relationships/image" Target="../media/image23.png"/><Relationship Id="rId22" Type="http://schemas.openxmlformats.org/officeDocument/2006/relationships/image" Target="../media/image22.png"/><Relationship Id="rId21" Type="http://schemas.openxmlformats.org/officeDocument/2006/relationships/image" Target="../media/image21.png"/><Relationship Id="rId20" Type="http://schemas.openxmlformats.org/officeDocument/2006/relationships/image" Target="../media/image20.png"/><Relationship Id="rId2" Type="http://schemas.openxmlformats.org/officeDocument/2006/relationships/image" Target="../media/image2.png"/><Relationship Id="rId19" Type="http://schemas.openxmlformats.org/officeDocument/2006/relationships/image" Target="../media/image19.png"/><Relationship Id="rId18" Type="http://schemas.openxmlformats.org/officeDocument/2006/relationships/image" Target="../media/image18.png"/><Relationship Id="rId17" Type="http://schemas.openxmlformats.org/officeDocument/2006/relationships/image" Target="../media/image17.png"/><Relationship Id="rId16" Type="http://schemas.openxmlformats.org/officeDocument/2006/relationships/image" Target="../media/image16.png"/><Relationship Id="rId15" Type="http://schemas.openxmlformats.org/officeDocument/2006/relationships/image" Target="../media/image15.png"/><Relationship Id="rId14" Type="http://schemas.openxmlformats.org/officeDocument/2006/relationships/image" Target="../media/image14.png"/><Relationship Id="rId13" Type="http://schemas.openxmlformats.org/officeDocument/2006/relationships/image" Target="../media/image13.png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64.xml"/><Relationship Id="rId2" Type="http://schemas.openxmlformats.org/officeDocument/2006/relationships/image" Target="../media/image26.tiff"/><Relationship Id="rId1" Type="http://schemas.openxmlformats.org/officeDocument/2006/relationships/image" Target="../media/image25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5.xml"/><Relationship Id="rId1" Type="http://schemas.openxmlformats.org/officeDocument/2006/relationships/image" Target="../media/image2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6.xml"/><Relationship Id="rId1" Type="http://schemas.openxmlformats.org/officeDocument/2006/relationships/image" Target="../media/image28.png"/></Relationships>
</file>

<file path=ppt/slides/_rels/slide5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67.xml"/><Relationship Id="rId2" Type="http://schemas.openxmlformats.org/officeDocument/2006/relationships/image" Target="../media/image30.png"/><Relationship Id="rId1" Type="http://schemas.openxmlformats.org/officeDocument/2006/relationships/image" Target="../media/image2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structureAhcpp1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9530" y="14605"/>
            <a:ext cx="1572895" cy="1572895"/>
          </a:xfrm>
          <a:prstGeom prst="rect">
            <a:avLst/>
          </a:prstGeom>
        </p:spPr>
      </p:pic>
      <p:pic>
        <p:nvPicPr>
          <p:cNvPr id="5" name="图片 4" descr="structureAhCPP2-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2425" y="18415"/>
            <a:ext cx="1613535" cy="157289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55010" y="14605"/>
            <a:ext cx="1599565" cy="157289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73625" y="18415"/>
            <a:ext cx="1591945" cy="157289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75730" y="18415"/>
            <a:ext cx="1602740" cy="156019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095615" y="19050"/>
            <a:ext cx="1649730" cy="155956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30480" y="-635"/>
            <a:ext cx="333375" cy="3181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A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606550" y="-46355"/>
            <a:ext cx="342900" cy="31750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B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3180" y="1602740"/>
            <a:ext cx="1584960" cy="1565275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3227070" y="-41275"/>
            <a:ext cx="333375" cy="3181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C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4836160" y="-23495"/>
            <a:ext cx="333375" cy="30480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D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6470650" y="-56515"/>
            <a:ext cx="333375" cy="3181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E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8086090" y="-26035"/>
            <a:ext cx="333375" cy="3181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F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632585" y="1602740"/>
            <a:ext cx="1614170" cy="1564640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251200" y="1602740"/>
            <a:ext cx="1599565" cy="1572260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869815" y="1602740"/>
            <a:ext cx="1593850" cy="1570355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473825" y="1603375"/>
            <a:ext cx="1617980" cy="1569720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104505" y="1603375"/>
            <a:ext cx="1639570" cy="1570990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2545" y="3183255"/>
            <a:ext cx="1579245" cy="1587500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641475" y="3184525"/>
            <a:ext cx="1604645" cy="1576705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262630" y="3190240"/>
            <a:ext cx="1590675" cy="1568450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869815" y="3197860"/>
            <a:ext cx="1591945" cy="1562100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478270" y="3197860"/>
            <a:ext cx="1599565" cy="1570990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8094345" y="3190240"/>
            <a:ext cx="1640840" cy="1588770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0480" y="4778375"/>
            <a:ext cx="1597660" cy="1627505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641475" y="4776470"/>
            <a:ext cx="1604010" cy="1633220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261995" y="4773930"/>
            <a:ext cx="1598295" cy="1635760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874260" y="4779010"/>
            <a:ext cx="1590040" cy="1631315"/>
          </a:xfrm>
          <a:prstGeom prst="rect">
            <a:avLst/>
          </a:prstGeom>
        </p:spPr>
      </p:pic>
      <p:pic>
        <p:nvPicPr>
          <p:cNvPr id="36" name="图片 35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6482715" y="4783455"/>
            <a:ext cx="1603375" cy="1621790"/>
          </a:xfrm>
          <a:prstGeom prst="rect">
            <a:avLst/>
          </a:prstGeom>
        </p:spPr>
      </p:pic>
      <p:pic>
        <p:nvPicPr>
          <p:cNvPr id="37" name="图片 36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8091805" y="4794885"/>
            <a:ext cx="1637030" cy="1615440"/>
          </a:xfrm>
          <a:prstGeom prst="rect">
            <a:avLst/>
          </a:prstGeom>
        </p:spPr>
      </p:pic>
      <p:sp>
        <p:nvSpPr>
          <p:cNvPr id="38" name="文本框 37"/>
          <p:cNvSpPr txBox="1"/>
          <p:nvPr/>
        </p:nvSpPr>
        <p:spPr>
          <a:xfrm>
            <a:off x="65405" y="1619885"/>
            <a:ext cx="333375" cy="3181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G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1641475" y="1564640"/>
            <a:ext cx="342900" cy="31750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H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3261995" y="1579245"/>
            <a:ext cx="333375" cy="3181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I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4871085" y="1597025"/>
            <a:ext cx="333375" cy="30480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J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6505575" y="1564005"/>
            <a:ext cx="333375" cy="3181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K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8121015" y="1594485"/>
            <a:ext cx="333375" cy="3181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L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66040" y="3223895"/>
            <a:ext cx="333375" cy="3181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M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1642110" y="3168650"/>
            <a:ext cx="342900" cy="31750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N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3262630" y="3183255"/>
            <a:ext cx="333375" cy="3181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O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4871720" y="3201035"/>
            <a:ext cx="333375" cy="30480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P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6506210" y="3168015"/>
            <a:ext cx="333375" cy="3181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Q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8121650" y="3198495"/>
            <a:ext cx="333375" cy="3181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R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65405" y="4775835"/>
            <a:ext cx="333375" cy="3181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S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1624965" y="4751070"/>
            <a:ext cx="342900" cy="31750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T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3245485" y="4765675"/>
            <a:ext cx="333375" cy="3181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U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4854575" y="4783455"/>
            <a:ext cx="333375" cy="30480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V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6489065" y="4750435"/>
            <a:ext cx="333375" cy="3181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W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8104505" y="4780915"/>
            <a:ext cx="333375" cy="3181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60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</a:rPr>
              <a:t>X</a:t>
            </a:r>
            <a:endParaRPr lang="en-US" altLang="zh-CN" sz="160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9744710" y="177165"/>
            <a:ext cx="2446655" cy="279209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 b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Fig. S1 tertiary structure of all AhCPP proteins.</a:t>
            </a:r>
            <a:endParaRPr lang="en-US" altLang="zh-CN" sz="1800" b="1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  <a:p>
            <a:pPr algn="l">
              <a:lnSpc>
                <a:spcPct val="150000"/>
              </a:lnSpc>
            </a:pPr>
            <a:r>
              <a:rPr lang="en-US" altLang="zh-CN" sz="18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A-X:</a:t>
            </a:r>
            <a:r>
              <a:rPr lang="en-US" altLang="zh-CN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AhCPP1-</a:t>
            </a:r>
            <a:r>
              <a:rPr lang="en-US" altLang="zh-CN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AhCPP24</a:t>
            </a:r>
            <a:endParaRPr lang="en-US" altLang="zh-CN" sz="180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</p:spTree>
    <p:custDataLst>
      <p:tags r:id="rId25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Figure S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784340" y="0"/>
            <a:ext cx="5407660" cy="6858000"/>
          </a:xfrm>
          <a:prstGeom prst="rect">
            <a:avLst/>
          </a:prstGeom>
        </p:spPr>
      </p:pic>
      <p:pic>
        <p:nvPicPr>
          <p:cNvPr id="5" name="图片 4" descr="Figure S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405" y="219075"/>
            <a:ext cx="6718935" cy="486791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65405" y="80645"/>
            <a:ext cx="377825" cy="3689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000">
                <a:latin typeface="Arial" panose="020B0604020202020204" pitchFamily="34" charset="0"/>
                <a:ea typeface="微软雅黑" panose="020B0503020204020204" charset="-122"/>
              </a:rPr>
              <a:t>A</a:t>
            </a:r>
            <a:endParaRPr lang="en-US" altLang="zh-CN" sz="20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6965315" y="80645"/>
            <a:ext cx="377825" cy="36893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000">
                <a:latin typeface="Arial" panose="020B0604020202020204" pitchFamily="34" charset="0"/>
                <a:ea typeface="微软雅黑" panose="020B0503020204020204" charset="-122"/>
              </a:rPr>
              <a:t>B</a:t>
            </a:r>
            <a:endParaRPr lang="en-US" altLang="zh-CN" sz="20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-635" y="5179695"/>
            <a:ext cx="6858635" cy="167830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 b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Fig. S2 Conserved Structural Sequence Analysis and Domain Presentation.</a:t>
            </a:r>
            <a:endParaRPr lang="en-US" altLang="zh-CN" sz="1800" b="1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  <a:p>
            <a:pPr algn="l"/>
            <a:r>
              <a:rPr lang="en-US" altLang="zh-CN" sz="18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(A) </a:t>
            </a:r>
            <a:r>
              <a:rPr lang="en-US" altLang="zh-CN" b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Conserved Structural Sequence Analysis </a:t>
            </a:r>
            <a:endParaRPr lang="en-US" altLang="zh-CN" b="1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  <a:sym typeface="+mn-ea"/>
            </a:endParaRPr>
          </a:p>
          <a:p>
            <a:pPr algn="l"/>
            <a:r>
              <a:rPr lang="en-US" altLang="zh-CN" sz="18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(B) </a:t>
            </a:r>
            <a:r>
              <a:rPr lang="en-US" altLang="zh-CN" sz="1800" b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Domain organization of CPP genes in Peanut</a:t>
            </a:r>
            <a:r>
              <a:rPr lang="en-US" altLang="zh-CN" sz="18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. Motif architecture is demonstrated as different shaped and different colored boxes. CXC, Cysteine-rich Polycomb-like Protein domain.</a:t>
            </a:r>
            <a:endParaRPr lang="en-US" altLang="zh-CN" sz="180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</p:spTree>
    <p:custDataLst>
      <p:tags r:id="rId3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Figure S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9050" y="0"/>
            <a:ext cx="10135870" cy="515874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65430" y="5252720"/>
            <a:ext cx="11521440" cy="133794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>
              <a:lnSpc>
                <a:spcPct val="150000"/>
              </a:lnSpc>
            </a:pPr>
            <a:r>
              <a:rPr lang="en-US" altLang="zh-CN" sz="1800" b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Fig. S3 The Ka/Ks value of paralog pairs of AhCPP in peanut. </a:t>
            </a:r>
            <a:endParaRPr lang="en-US" altLang="zh-CN" sz="1800" b="1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  <a:p>
            <a:pPr algn="l">
              <a:lnSpc>
                <a:spcPct val="150000"/>
              </a:lnSpc>
            </a:pPr>
            <a:r>
              <a:rPr lang="en-US" altLang="zh-CN" sz="18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The blue bars represent Ka values, while the brownish yellow bars represent Ks values, and Ka/Ks  values are shown by a green line. The vertical line and horizontal line indicate the values of Ka, Ks, Ka/Ks and paralog pairs, respectively</a:t>
            </a:r>
            <a:endParaRPr lang="en-US" altLang="zh-CN" sz="180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</p:spTree>
    <p:custDataLst>
      <p:tags r:id="rId2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Figure S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142875"/>
            <a:ext cx="12192000" cy="397637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22555" y="4443095"/>
            <a:ext cx="11778615" cy="172212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>
              <a:lnSpc>
                <a:spcPct val="150000"/>
              </a:lnSpc>
            </a:pPr>
            <a:r>
              <a:rPr lang="en-US" altLang="zh-CN" sz="1800" b="1">
                <a:latin typeface="Arial" panose="020B0604020202020204" pitchFamily="34" charset="0"/>
                <a:ea typeface="微软雅黑" panose="020B0503020204020204" charset="-122"/>
              </a:rPr>
              <a:t>Fig. S4 Prediction of cis-elements in the promoters of peanut CPP genes. </a:t>
            </a:r>
            <a:endParaRPr lang="en-US" altLang="zh-CN" sz="1800" b="1">
              <a:latin typeface="Arial" panose="020B0604020202020204" pitchFamily="34" charset="0"/>
              <a:ea typeface="微软雅黑" panose="020B0503020204020204" charset="-122"/>
            </a:endParaRPr>
          </a:p>
          <a:p>
            <a:pPr algn="l">
              <a:lnSpc>
                <a:spcPct val="150000"/>
              </a:lnSpc>
            </a:pPr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Putative cis-elements were detected in 2-kb promoters of peanut CPP genes. The horizontal axis indicates region </a:t>
            </a:r>
            <a:r>
              <a:rPr lang="en-US" altLang="zh-CN" sz="18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nucleotide </a:t>
            </a:r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length of gene promoter; the color bar code represents the diferent cis-elements in the promoter region. The phylogenetic tree is the same as that of Fig. 1.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</p:spTree>
    <p:custDataLst>
      <p:tags r:id="rId2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IMG_20251106_162006-恢复的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0"/>
            <a:ext cx="6251575" cy="403923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255905" y="4479925"/>
            <a:ext cx="11241405" cy="2296160"/>
          </a:xfrm>
          <a:prstGeom prst="rect">
            <a:avLst/>
          </a:prstGeom>
        </p:spPr>
        <p:txBody>
          <a:bodyPr>
            <a:noAutofit/>
          </a:bodyPr>
          <a:p>
            <a:pPr marL="0" indent="0"/>
            <a:r>
              <a:rPr lang="en-US" altLang="zh-CN" sz="1600" b="1" i="0">
                <a:solidFill>
                  <a:srgbClr val="0F1115"/>
                </a:solidFill>
                <a:latin typeface="Times New Roman" panose="02020603050405020304" charset="0"/>
                <a:ea typeface="quote-cjk-patch"/>
                <a:cs typeface="Times New Roman" panose="02020603050405020304" charset="0"/>
              </a:rPr>
              <a:t>Fig.S5. Phenotypic of peanut under normal and stressed conditions.</a:t>
            </a:r>
            <a:endParaRPr lang="en-US" altLang="zh-CN" sz="1600" b="1" i="0">
              <a:solidFill>
                <a:srgbClr val="0F1115"/>
              </a:solidFill>
              <a:latin typeface="Times New Roman" panose="02020603050405020304" charset="0"/>
              <a:ea typeface="quote-cjk-patch"/>
              <a:cs typeface="Times New Roman" panose="02020603050405020304" charset="0"/>
            </a:endParaRPr>
          </a:p>
          <a:p>
            <a:pPr marL="0" indent="0">
              <a:lnSpc>
                <a:spcPct val="150000"/>
              </a:lnSpc>
            </a:pPr>
            <a:r>
              <a:rPr lang="en-US" altLang="zh-CN" sz="1600" i="0">
                <a:solidFill>
                  <a:srgbClr val="0F1115"/>
                </a:solidFill>
                <a:latin typeface="Times New Roman" panose="02020603050405020304" charset="0"/>
                <a:ea typeface="quote-cjk-patch"/>
                <a:cs typeface="Times New Roman" panose="02020603050405020304" charset="0"/>
              </a:rPr>
              <a:t>Phenotypic observations of peanut seedlings after 5 days of treatment under normal conditions, 20% PEG-6000-simulated drought stress, and 200 mmol/L NaCl salt stress. (A) Seedling morphology under normal and stressed conditions. (B) Statistical analysis of primary root length, hypocotyl length, and leaf width. Data are presented as mean </a:t>
            </a:r>
            <a:r>
              <a:rPr lang="en-US" altLang="en-US" sz="1600" i="0">
                <a:solidFill>
                  <a:srgbClr val="0F1115"/>
                </a:solidFill>
                <a:latin typeface="Times New Roman" panose="02020603050405020304" charset="0"/>
                <a:ea typeface="quote-cjk-patch"/>
                <a:cs typeface="Times New Roman" panose="02020603050405020304" charset="0"/>
              </a:rPr>
              <a:t>±</a:t>
            </a:r>
            <a:r>
              <a:rPr lang="en-US" altLang="zh-CN" sz="1600" i="0">
                <a:solidFill>
                  <a:srgbClr val="0F1115"/>
                </a:solidFill>
                <a:latin typeface="Times New Roman" panose="02020603050405020304" charset="0"/>
                <a:ea typeface="quote-cjk-patch"/>
                <a:cs typeface="Times New Roman" panose="02020603050405020304" charset="0"/>
              </a:rPr>
              <a:t> SD (n = 3 biological replicates). *p &lt; 0.05, **p &lt; 0.01 (Student's t-test) indicate significant differences compared to the normal condition.</a:t>
            </a:r>
            <a:endParaRPr lang="en-US" altLang="zh-CN" sz="1600" i="0">
              <a:solidFill>
                <a:srgbClr val="0F1115"/>
              </a:solidFill>
              <a:latin typeface="Times New Roman" panose="02020603050405020304" charset="0"/>
              <a:ea typeface="quote-cjk-patch"/>
              <a:cs typeface="Times New Roman" panose="02020603050405020304" charset="0"/>
            </a:endParaRPr>
          </a:p>
        </p:txBody>
      </p:sp>
      <p:pic>
        <p:nvPicPr>
          <p:cNvPr id="7" name="图片 6" descr="Data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51575" y="0"/>
            <a:ext cx="4719955" cy="424815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0" y="0"/>
            <a:ext cx="587375" cy="60579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 b="1">
                <a:latin typeface="Arial" panose="020B0604020202020204" pitchFamily="34" charset="0"/>
                <a:ea typeface="微软雅黑" panose="020B0503020204020204" charset="-122"/>
              </a:rPr>
              <a:t>A</a:t>
            </a:r>
            <a:endParaRPr lang="en-US" altLang="zh-CN" sz="1800" b="1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251575" y="0"/>
            <a:ext cx="587375" cy="60579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 b="1">
                <a:latin typeface="Arial" panose="020B0604020202020204" pitchFamily="34" charset="0"/>
                <a:ea typeface="微软雅黑" panose="020B0503020204020204" charset="-122"/>
              </a:rPr>
              <a:t>B</a:t>
            </a:r>
            <a:endParaRPr lang="en-US" altLang="zh-CN" sz="1800" b="1">
              <a:latin typeface="Arial" panose="020B0604020202020204" pitchFamily="34" charset="0"/>
              <a:ea typeface="微软雅黑" panose="020B0503020204020204" charset="-122"/>
            </a:endParaRPr>
          </a:p>
        </p:txBody>
      </p:sp>
    </p:spTree>
    <p:custDataLst>
      <p:tags r:id="rId3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89</Words>
  <Application>WPS 演示</Application>
  <PresentationFormat>宽屏</PresentationFormat>
  <Paragraphs>72</Paragraphs>
  <Slides>5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7" baseType="lpstr">
      <vt:lpstr>Arial</vt:lpstr>
      <vt:lpstr>宋体</vt:lpstr>
      <vt:lpstr>Wingdings</vt:lpstr>
      <vt:lpstr>Wingdings</vt:lpstr>
      <vt:lpstr>微软雅黑</vt:lpstr>
      <vt:lpstr>Times New Roman</vt:lpstr>
      <vt:lpstr>quote-cjk-patch</vt:lpstr>
      <vt:lpstr>Segoe Print</vt:lpstr>
      <vt:lpstr>Arial Unicode MS</vt:lpstr>
      <vt:lpstr>Calibri</vt:lpstr>
      <vt:lpstr>quote-cjk-patch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白羊</cp:lastModifiedBy>
  <cp:revision>166</cp:revision>
  <dcterms:created xsi:type="dcterms:W3CDTF">2019-06-19T02:08:00Z</dcterms:created>
  <dcterms:modified xsi:type="dcterms:W3CDTF">2026-03-16T13:44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225</vt:lpwstr>
  </property>
  <property fmtid="{D5CDD505-2E9C-101B-9397-08002B2CF9AE}" pid="3" name="ICV">
    <vt:lpwstr>26BA258E4CD64F5287A5F77BDA6C99AB_13</vt:lpwstr>
  </property>
</Properties>
</file>